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0" autoAdjust="0"/>
    <p:restoredTop sz="94660"/>
  </p:normalViewPr>
  <p:slideViewPr>
    <p:cSldViewPr snapToGrid="0">
      <p:cViewPr varScale="1">
        <p:scale>
          <a:sx n="90" d="100"/>
          <a:sy n="90" d="100"/>
        </p:scale>
        <p:origin x="1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28819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83623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70306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00225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10141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55097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10755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6730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3991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37844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9302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FF2B-52F1-4182-A6BB-DC861103194B}" type="datetimeFigureOut">
              <a:rPr lang="en-NZ" smtClean="0"/>
              <a:t>21/08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65F1C-3EFD-40E1-9D26-7251ED509BA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64286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>
            <a:extLst>
              <a:ext uri="{FF2B5EF4-FFF2-40B4-BE49-F238E27FC236}">
                <a16:creationId xmlns:a16="http://schemas.microsoft.com/office/drawing/2014/main" id="{8A9B0ED3-ADEA-3174-0B7F-E00A5B0FA13D}"/>
              </a:ext>
            </a:extLst>
          </p:cNvPr>
          <p:cNvGrpSpPr/>
          <p:nvPr/>
        </p:nvGrpSpPr>
        <p:grpSpPr>
          <a:xfrm>
            <a:off x="-220688" y="216806"/>
            <a:ext cx="10023664" cy="3366746"/>
            <a:chOff x="-390816" y="567691"/>
            <a:chExt cx="10023664" cy="336674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A51620F-63C0-6DF7-F72F-132FD68DBF24}"/>
                </a:ext>
              </a:extLst>
            </p:cNvPr>
            <p:cNvGrpSpPr/>
            <p:nvPr/>
          </p:nvGrpSpPr>
          <p:grpSpPr>
            <a:xfrm>
              <a:off x="-390816" y="567691"/>
              <a:ext cx="10023664" cy="3120390"/>
              <a:chOff x="-390816" y="567691"/>
              <a:chExt cx="10023664" cy="3120390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2EA246D2-B7F7-CCAC-94A2-5D431EF00A8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9989" y="567691"/>
                <a:ext cx="3201467" cy="3120390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658AFFF-4CBC-5AEB-6D19-5842F7CB5D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320367" y="567691"/>
                <a:ext cx="3201467" cy="3120390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6830A453-8AB5-1C1C-3813-5FD08A266D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431381" y="567691"/>
                <a:ext cx="3201467" cy="3120390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2119CC93-E8C8-754D-B06A-E319DA75657C}"/>
                  </a:ext>
                </a:extLst>
              </p:cNvPr>
              <p:cNvSpPr txBox="1"/>
              <p:nvPr/>
            </p:nvSpPr>
            <p:spPr>
              <a:xfrm>
                <a:off x="-390816" y="1726730"/>
                <a:ext cx="800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NZ" sz="1400" b="1" dirty="0"/>
                  <a:t>10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56828C8-E6BC-21D7-D995-CBE352BDFDB7}"/>
                  </a:ext>
                </a:extLst>
              </p:cNvPr>
              <p:cNvSpPr txBox="1"/>
              <p:nvPr/>
            </p:nvSpPr>
            <p:spPr>
              <a:xfrm>
                <a:off x="-390816" y="3066644"/>
                <a:ext cx="800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NZ" sz="1400" b="1" dirty="0"/>
                  <a:t>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DDE041B-3961-2B11-B957-0B997393223B}"/>
                  </a:ext>
                </a:extLst>
              </p:cNvPr>
              <p:cNvSpPr txBox="1"/>
              <p:nvPr/>
            </p:nvSpPr>
            <p:spPr>
              <a:xfrm>
                <a:off x="-390816" y="735312"/>
                <a:ext cx="800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NZ" sz="1400" b="1" dirty="0"/>
                  <a:t>2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DA0F9C30-093E-C841-2207-C5D5561CED4F}"/>
                  </a:ext>
                </a:extLst>
              </p:cNvPr>
              <p:cNvSpPr txBox="1"/>
              <p:nvPr/>
            </p:nvSpPr>
            <p:spPr>
              <a:xfrm>
                <a:off x="-390816" y="2327862"/>
                <a:ext cx="800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NZ" sz="1400" b="1" dirty="0"/>
                  <a:t>5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6A79EC2-6042-3419-CF27-7108EE886EAB}"/>
                  </a:ext>
                </a:extLst>
              </p:cNvPr>
              <p:cNvSpPr txBox="1"/>
              <p:nvPr/>
            </p:nvSpPr>
            <p:spPr>
              <a:xfrm>
                <a:off x="-390816" y="1198645"/>
                <a:ext cx="800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NZ" sz="1400" b="1" dirty="0"/>
                  <a:t>15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B2794CE-81E1-27F6-4A6A-52B184B2D225}"/>
                </a:ext>
              </a:extLst>
            </p:cNvPr>
            <p:cNvSpPr txBox="1"/>
            <p:nvPr/>
          </p:nvSpPr>
          <p:spPr>
            <a:xfrm>
              <a:off x="464546" y="682636"/>
              <a:ext cx="281028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400" b="1" dirty="0"/>
                <a:t>IESR – intrusiveness scor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60B423C-3EB2-1A9F-31A1-91C60B984795}"/>
                </a:ext>
              </a:extLst>
            </p:cNvPr>
            <p:cNvSpPr txBox="1"/>
            <p:nvPr/>
          </p:nvSpPr>
          <p:spPr>
            <a:xfrm>
              <a:off x="3562162" y="682636"/>
              <a:ext cx="281028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400" b="1" dirty="0"/>
                <a:t>IESR – avoidance scor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B6B8249-516C-76E9-2D3B-7499684A1B62}"/>
                </a:ext>
              </a:extLst>
            </p:cNvPr>
            <p:cNvSpPr txBox="1"/>
            <p:nvPr/>
          </p:nvSpPr>
          <p:spPr>
            <a:xfrm>
              <a:off x="6681053" y="682636"/>
              <a:ext cx="281028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400" b="1" dirty="0"/>
                <a:t>IESR – hyperarousal score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F55D626D-4727-CEB5-C8F9-AB347BCE0CF6}"/>
                </a:ext>
              </a:extLst>
            </p:cNvPr>
            <p:cNvGrpSpPr/>
            <p:nvPr/>
          </p:nvGrpSpPr>
          <p:grpSpPr>
            <a:xfrm>
              <a:off x="266326" y="3307968"/>
              <a:ext cx="3150159" cy="626469"/>
              <a:chOff x="266326" y="3307968"/>
              <a:chExt cx="3150159" cy="626469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371A647-251C-65B0-DD37-7D5DBF8B0A18}"/>
                  </a:ext>
                </a:extLst>
              </p:cNvPr>
              <p:cNvSpPr txBox="1"/>
              <p:nvPr/>
            </p:nvSpPr>
            <p:spPr>
              <a:xfrm>
                <a:off x="266326" y="3307968"/>
                <a:ext cx="36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325ACD0-F438-2586-1858-A8FAD9193948}"/>
                  </a:ext>
                </a:extLst>
              </p:cNvPr>
              <p:cNvSpPr txBox="1"/>
              <p:nvPr/>
            </p:nvSpPr>
            <p:spPr>
              <a:xfrm>
                <a:off x="781245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5BDD92B-BF1A-C426-4D66-A0C1ECA38A65}"/>
                  </a:ext>
                </a:extLst>
              </p:cNvPr>
              <p:cNvSpPr txBox="1"/>
              <p:nvPr/>
            </p:nvSpPr>
            <p:spPr>
              <a:xfrm>
                <a:off x="1478628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BEF93EA-D1A3-ABE1-0F09-3B829023BA91}"/>
                  </a:ext>
                </a:extLst>
              </p:cNvPr>
              <p:cNvSpPr txBox="1"/>
              <p:nvPr/>
            </p:nvSpPr>
            <p:spPr>
              <a:xfrm>
                <a:off x="2175803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4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7AB1F33-FF9A-03A4-24B7-790671BABC7A}"/>
                  </a:ext>
                </a:extLst>
              </p:cNvPr>
              <p:cNvSpPr txBox="1"/>
              <p:nvPr/>
            </p:nvSpPr>
            <p:spPr>
              <a:xfrm>
                <a:off x="2876485" y="3307968"/>
                <a:ext cx="54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68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53504CD-E048-EC77-F401-BCD902615EC3}"/>
                  </a:ext>
                </a:extLst>
              </p:cNvPr>
              <p:cNvSpPr txBox="1"/>
              <p:nvPr/>
            </p:nvSpPr>
            <p:spPr>
              <a:xfrm>
                <a:off x="473189" y="3626660"/>
                <a:ext cx="271657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time (h)</a:t>
                </a:r>
              </a:p>
            </p:txBody>
          </p: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BC6A62F4-2E1E-6176-59C1-E0DDAB067EED}"/>
                </a:ext>
              </a:extLst>
            </p:cNvPr>
            <p:cNvGrpSpPr/>
            <p:nvPr/>
          </p:nvGrpSpPr>
          <p:grpSpPr>
            <a:xfrm>
              <a:off x="3354150" y="3307968"/>
              <a:ext cx="3150159" cy="626469"/>
              <a:chOff x="266326" y="3307968"/>
              <a:chExt cx="3150159" cy="626469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95FF551-D4AC-8EA2-107D-91E266309871}"/>
                  </a:ext>
                </a:extLst>
              </p:cNvPr>
              <p:cNvSpPr txBox="1"/>
              <p:nvPr/>
            </p:nvSpPr>
            <p:spPr>
              <a:xfrm>
                <a:off x="266326" y="3307968"/>
                <a:ext cx="36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90DA9392-8B9F-E0D6-57C7-767538300237}"/>
                  </a:ext>
                </a:extLst>
              </p:cNvPr>
              <p:cNvSpPr txBox="1"/>
              <p:nvPr/>
            </p:nvSpPr>
            <p:spPr>
              <a:xfrm>
                <a:off x="781245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0E9BF2EC-E3E1-089A-1008-22518705A834}"/>
                  </a:ext>
                </a:extLst>
              </p:cNvPr>
              <p:cNvSpPr txBox="1"/>
              <p:nvPr/>
            </p:nvSpPr>
            <p:spPr>
              <a:xfrm>
                <a:off x="1478628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A9A3D0E-755E-C3CA-B0F7-AD770B7179B8}"/>
                  </a:ext>
                </a:extLst>
              </p:cNvPr>
              <p:cNvSpPr txBox="1"/>
              <p:nvPr/>
            </p:nvSpPr>
            <p:spPr>
              <a:xfrm>
                <a:off x="2175803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4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06B1BEF5-9AF7-A689-7F52-E1BAD2060FD2}"/>
                  </a:ext>
                </a:extLst>
              </p:cNvPr>
              <p:cNvSpPr txBox="1"/>
              <p:nvPr/>
            </p:nvSpPr>
            <p:spPr>
              <a:xfrm>
                <a:off x="2876485" y="3307968"/>
                <a:ext cx="54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68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2817041-F842-2EEF-2831-457816C7F1C7}"/>
                  </a:ext>
                </a:extLst>
              </p:cNvPr>
              <p:cNvSpPr txBox="1"/>
              <p:nvPr/>
            </p:nvSpPr>
            <p:spPr>
              <a:xfrm>
                <a:off x="473189" y="3626660"/>
                <a:ext cx="271657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time (h)</a:t>
                </a:r>
              </a:p>
            </p:txBody>
          </p: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D9052277-C3A0-8CD7-2DB9-E2F476B1690D}"/>
                </a:ext>
              </a:extLst>
            </p:cNvPr>
            <p:cNvGrpSpPr/>
            <p:nvPr/>
          </p:nvGrpSpPr>
          <p:grpSpPr>
            <a:xfrm>
              <a:off x="6462406" y="3307968"/>
              <a:ext cx="3150159" cy="626469"/>
              <a:chOff x="266326" y="3307968"/>
              <a:chExt cx="3150159" cy="626469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5799A84E-0983-70BA-F66C-C87FE892356C}"/>
                  </a:ext>
                </a:extLst>
              </p:cNvPr>
              <p:cNvSpPr txBox="1"/>
              <p:nvPr/>
            </p:nvSpPr>
            <p:spPr>
              <a:xfrm>
                <a:off x="266326" y="3307968"/>
                <a:ext cx="36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0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A76AA8B-B96A-97DF-F9D2-DFC4E4D205EA}"/>
                  </a:ext>
                </a:extLst>
              </p:cNvPr>
              <p:cNvSpPr txBox="1"/>
              <p:nvPr/>
            </p:nvSpPr>
            <p:spPr>
              <a:xfrm>
                <a:off x="781245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12F0026-2FB7-4BDC-4963-3E733854B54D}"/>
                  </a:ext>
                </a:extLst>
              </p:cNvPr>
              <p:cNvSpPr txBox="1"/>
              <p:nvPr/>
            </p:nvSpPr>
            <p:spPr>
              <a:xfrm>
                <a:off x="1478628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B18C513B-FD32-2678-978E-99776353DF00}"/>
                  </a:ext>
                </a:extLst>
              </p:cNvPr>
              <p:cNvSpPr txBox="1"/>
              <p:nvPr/>
            </p:nvSpPr>
            <p:spPr>
              <a:xfrm>
                <a:off x="2175803" y="3307968"/>
                <a:ext cx="72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24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2A5EFBBD-E1F6-C08F-E175-A167249AA9F7}"/>
                  </a:ext>
                </a:extLst>
              </p:cNvPr>
              <p:cNvSpPr txBox="1"/>
              <p:nvPr/>
            </p:nvSpPr>
            <p:spPr>
              <a:xfrm>
                <a:off x="2876485" y="3307968"/>
                <a:ext cx="540000" cy="288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168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FEC520ED-C274-4240-1902-D8068602BA41}"/>
                  </a:ext>
                </a:extLst>
              </p:cNvPr>
              <p:cNvSpPr txBox="1"/>
              <p:nvPr/>
            </p:nvSpPr>
            <p:spPr>
              <a:xfrm>
                <a:off x="473189" y="3626660"/>
                <a:ext cx="271657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400" b="1" dirty="0"/>
                  <a:t>time (h)</a:t>
                </a:r>
              </a:p>
            </p:txBody>
          </p:sp>
        </p:grp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3B90A728-0F13-26E6-C849-DA1AF0BD294F}"/>
              </a:ext>
            </a:extLst>
          </p:cNvPr>
          <p:cNvSpPr txBox="1"/>
          <p:nvPr/>
        </p:nvSpPr>
        <p:spPr>
          <a:xfrm>
            <a:off x="613408" y="20411"/>
            <a:ext cx="9026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dirty="0"/>
              <a:t>Supplemental Figure 1 – mean (SEM) IESR subscale responses to study treatments</a:t>
            </a:r>
          </a:p>
        </p:txBody>
      </p:sp>
    </p:spTree>
    <p:extLst>
      <p:ext uri="{BB962C8B-B14F-4D97-AF65-F5344CB8AC3E}">
        <p14:creationId xmlns:p14="http://schemas.microsoft.com/office/powerpoint/2010/main" val="102502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1</TotalTime>
  <Words>58</Words>
  <Application>Microsoft Office PowerPoint</Application>
  <PresentationFormat>A4 Paper (210x297 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eil McNaughton</dc:creator>
  <cp:lastModifiedBy>Neil McNaughton</cp:lastModifiedBy>
  <cp:revision>10</cp:revision>
  <dcterms:created xsi:type="dcterms:W3CDTF">2024-08-12T03:49:53Z</dcterms:created>
  <dcterms:modified xsi:type="dcterms:W3CDTF">2024-08-21T00:42:32Z</dcterms:modified>
</cp:coreProperties>
</file>